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7" r:id="rId2"/>
  </p:sldIdLst>
  <p:sldSz cx="6858000" cy="9906000" type="A4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1616" userDrawn="1">
          <p15:clr>
            <a:srgbClr val="A4A3A4"/>
          </p15:clr>
        </p15:guide>
        <p15:guide id="2" orient="horz" pos="312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rta Giordano" initials="MG" lastIdx="2" clrIdx="0">
    <p:extLst>
      <p:ext uri="{19B8F6BF-5375-455C-9EA6-DF929625EA0E}">
        <p15:presenceInfo xmlns:p15="http://schemas.microsoft.com/office/powerpoint/2012/main" userId="85a35cf7a9d505e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18" autoAdjust="0"/>
    <p:restoredTop sz="94660"/>
  </p:normalViewPr>
  <p:slideViewPr>
    <p:cSldViewPr snapToGrid="0">
      <p:cViewPr varScale="1">
        <p:scale>
          <a:sx n="80" d="100"/>
          <a:sy n="80" d="100"/>
        </p:scale>
        <p:origin x="3426" y="114"/>
      </p:cViewPr>
      <p:guideLst>
        <p:guide pos="1616"/>
        <p:guide orient="horz"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91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933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464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69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0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277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77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185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700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710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879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07F28-0D1E-48D8-9BCF-AB3F42D94A80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1ABFF-EFA1-47C8-8FDF-C8C4BBF465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943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10">
            <a:extLst>
              <a:ext uri="{FF2B5EF4-FFF2-40B4-BE49-F238E27FC236}">
                <a16:creationId xmlns:a16="http://schemas.microsoft.com/office/drawing/2014/main" id="{AD40FBBE-1F81-47B6-841E-37A49C3D48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4967467"/>
              </p:ext>
            </p:extLst>
          </p:nvPr>
        </p:nvGraphicFramePr>
        <p:xfrm>
          <a:off x="382280" y="2515351"/>
          <a:ext cx="6104579" cy="238413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0935">
                  <a:extLst>
                    <a:ext uri="{9D8B030D-6E8A-4147-A177-3AD203B41FA5}">
                      <a16:colId xmlns:a16="http://schemas.microsoft.com/office/drawing/2014/main" val="1731880126"/>
                    </a:ext>
                  </a:extLst>
                </a:gridCol>
                <a:gridCol w="3540726">
                  <a:extLst>
                    <a:ext uri="{9D8B030D-6E8A-4147-A177-3AD203B41FA5}">
                      <a16:colId xmlns:a16="http://schemas.microsoft.com/office/drawing/2014/main" val="2784633029"/>
                    </a:ext>
                  </a:extLst>
                </a:gridCol>
                <a:gridCol w="1922918">
                  <a:extLst>
                    <a:ext uri="{9D8B030D-6E8A-4147-A177-3AD203B41FA5}">
                      <a16:colId xmlns:a16="http://schemas.microsoft.com/office/drawing/2014/main" val="621285052"/>
                    </a:ext>
                  </a:extLst>
                </a:gridCol>
              </a:tblGrid>
              <a:tr h="124734">
                <a:tc>
                  <a:txBody>
                    <a:bodyPr/>
                    <a:lstStyle/>
                    <a:p>
                      <a:pPr algn="ctr"/>
                      <a:r>
                        <a:rPr lang="es-AR" sz="75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</a:t>
                      </a:r>
                      <a:r>
                        <a:rPr lang="es-AR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D</a:t>
                      </a:r>
                      <a:endParaRPr lang="en-US" sz="7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en-US" sz="75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</a:t>
                      </a: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tment/s and response/s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ctions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6149330"/>
                  </a:ext>
                </a:extLst>
              </a:tr>
              <a:tr h="400319">
                <a:tc>
                  <a:txBody>
                    <a:bodyPr/>
                    <a:lstStyle/>
                    <a:p>
                      <a:pPr algn="ctr"/>
                      <a:r>
                        <a:rPr lang="es-AR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1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relapse / </a:t>
                      </a:r>
                      <a:r>
                        <a:rPr lang="en-US" sz="750" b="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+rituximab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relapse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s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e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lection two years after this treatment </a:t>
                      </a:r>
                    </a:p>
                    <a:p>
                      <a:pPr algn="ctr"/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ractoriness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o second </a:t>
                      </a:r>
                      <a:r>
                        <a:rPr lang="en-US" sz="750" b="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+rituximab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fter sample collection)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eumonia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fter refractoriness to </a:t>
                      </a:r>
                      <a:r>
                        <a:rPr lang="en-US" sz="750" b="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+rituximab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atient perished two months later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4668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s-AR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2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ient started </a:t>
                      </a:r>
                      <a:r>
                        <a:rPr lang="en-US" sz="750" b="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ment after sample collection</a:t>
                      </a:r>
                      <a:endParaRPr lang="en-US" sz="7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4565370"/>
                  </a:ext>
                </a:extLst>
              </a:tr>
              <a:tr h="357054">
                <a:tc>
                  <a:txBody>
                    <a:bodyPr/>
                    <a:lstStyle/>
                    <a:p>
                      <a:pPr algn="ctr"/>
                      <a:r>
                        <a:rPr lang="es-AR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8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started </a:t>
                      </a:r>
                      <a:r>
                        <a:rPr lang="en-US" sz="750" b="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ment after sample collection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eumonia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ue to infection with </a:t>
                      </a:r>
                      <a:r>
                        <a:rPr lang="en-US" sz="750" b="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plasma</a:t>
                      </a:r>
                      <a:r>
                        <a:rPr lang="en-US" sz="75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sulatum</a:t>
                      </a:r>
                      <a:r>
                        <a:rPr lang="en-US" sz="75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</a:t>
                      </a:r>
                      <a:r>
                        <a:rPr lang="en-US" sz="75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In treatment with</a:t>
                      </a:r>
                      <a:r>
                        <a:rPr lang="en-US" sz="750" b="0" i="0" baseline="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raconazole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76338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s-AR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9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o</a:t>
                      </a:r>
                      <a:r>
                        <a:rPr lang="en-US" sz="75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a half years before sample collection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886102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s-AR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14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AEAE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 patient in watch and wait monitoring mode to date.</a:t>
                      </a:r>
                      <a:endParaRPr lang="en-US" sz="7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AEA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AEA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15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started </a:t>
                      </a:r>
                      <a:r>
                        <a:rPr lang="en-US" sz="750" b="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dribine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reatment after sample collection.</a:t>
                      </a:r>
                      <a:endParaRPr lang="en-US" sz="7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</a:t>
                      </a:r>
                      <a:r>
                        <a:rPr lang="en-US" sz="75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lgrastim</a:t>
                      </a:r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s support</a:t>
                      </a:r>
                      <a:r>
                        <a:rPr lang="en-US" sz="75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alf year before sample collection.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43997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75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18</a:t>
                      </a: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 patient in watch and wait monitoring mode to date.</a:t>
                      </a:r>
                      <a:endParaRPr lang="en-US" sz="75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7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97162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75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#23</a:t>
                      </a:r>
                      <a:endParaRPr lang="en-US" sz="75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r>
                        <a:rPr lang="en-US" sz="75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5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 patient in watch and wait monitoring mode to date.</a:t>
                      </a:r>
                      <a:endParaRPr lang="en-US" sz="75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7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105" marR="87105" marT="43552" marB="43552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164079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109747" y="2041336"/>
            <a:ext cx="2500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35479"/>
            <a:r>
              <a:rPr lang="fr-FR" sz="14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able 1</a:t>
            </a:r>
            <a:endParaRPr lang="fr-CH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897668" y="3213573"/>
            <a:ext cx="76195" cy="808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Isosceles Triangle 6"/>
          <p:cNvSpPr/>
          <p:nvPr/>
        </p:nvSpPr>
        <p:spPr>
          <a:xfrm>
            <a:off x="914393" y="3844311"/>
            <a:ext cx="66675" cy="74805"/>
          </a:xfrm>
          <a:prstGeom prst="triangl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Oval 7"/>
          <p:cNvSpPr/>
          <p:nvPr/>
        </p:nvSpPr>
        <p:spPr>
          <a:xfrm>
            <a:off x="897310" y="3525059"/>
            <a:ext cx="86934" cy="83027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Isosceles Triangle 8"/>
          <p:cNvSpPr/>
          <p:nvPr/>
        </p:nvSpPr>
        <p:spPr>
          <a:xfrm flipV="1">
            <a:off x="912800" y="4047523"/>
            <a:ext cx="66675" cy="74805"/>
          </a:xfrm>
          <a:prstGeom prst="triangl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/>
          <p:cNvSpPr/>
          <p:nvPr/>
        </p:nvSpPr>
        <p:spPr>
          <a:xfrm rot="2700000">
            <a:off x="892173" y="2895971"/>
            <a:ext cx="76195" cy="80819"/>
          </a:xfrm>
          <a:prstGeom prst="rect">
            <a:avLst/>
          </a:prstGeom>
          <a:solidFill>
            <a:schemeClr val="l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1" name="Group 10"/>
          <p:cNvGrpSpPr/>
          <p:nvPr/>
        </p:nvGrpSpPr>
        <p:grpSpPr>
          <a:xfrm>
            <a:off x="901693" y="4557396"/>
            <a:ext cx="85855" cy="85855"/>
            <a:chOff x="476515" y="6653012"/>
            <a:chExt cx="85855" cy="85855"/>
          </a:xfrm>
        </p:grpSpPr>
        <p:sp>
          <p:nvSpPr>
            <p:cNvPr id="12" name="Rectangle 11"/>
            <p:cNvSpPr/>
            <p:nvPr/>
          </p:nvSpPr>
          <p:spPr>
            <a:xfrm>
              <a:off x="482362" y="6653779"/>
              <a:ext cx="76195" cy="808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3" name="Straight Connector 12"/>
            <p:cNvCxnSpPr/>
            <p:nvPr/>
          </p:nvCxnSpPr>
          <p:spPr>
            <a:xfrm flipH="1">
              <a:off x="476515" y="6655684"/>
              <a:ext cx="85855" cy="8081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rot="5400000" flipH="1">
              <a:off x="478112" y="6655530"/>
              <a:ext cx="85855" cy="8081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Hexagon 14"/>
          <p:cNvSpPr/>
          <p:nvPr/>
        </p:nvSpPr>
        <p:spPr>
          <a:xfrm>
            <a:off x="899042" y="4300211"/>
            <a:ext cx="95626" cy="91440"/>
          </a:xfrm>
          <a:prstGeom prst="hexagon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Rectangle 1"/>
          <p:cNvSpPr/>
          <p:nvPr/>
        </p:nvSpPr>
        <p:spPr>
          <a:xfrm>
            <a:off x="307848" y="4970917"/>
            <a:ext cx="6104579" cy="2580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Additional clinical information of the HCL patients included in this study. </a:t>
            </a:r>
            <a:endParaRPr lang="fr-CH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901392" y="4753546"/>
            <a:ext cx="86934" cy="83027"/>
            <a:chOff x="463312" y="6655885"/>
            <a:chExt cx="86934" cy="83027"/>
          </a:xfrm>
        </p:grpSpPr>
        <p:sp>
          <p:nvSpPr>
            <p:cNvPr id="17" name="Oval 16"/>
            <p:cNvSpPr/>
            <p:nvPr/>
          </p:nvSpPr>
          <p:spPr>
            <a:xfrm>
              <a:off x="463312" y="6655885"/>
              <a:ext cx="86934" cy="83027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473046" y="6661021"/>
              <a:ext cx="66461" cy="69655"/>
              <a:chOff x="550246" y="7126414"/>
              <a:chExt cx="85855" cy="85855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 flipH="1">
                <a:off x="550246" y="7129086"/>
                <a:ext cx="85855" cy="8081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rot="5400000" flipH="1">
                <a:off x="551843" y="7128932"/>
                <a:ext cx="85855" cy="8081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230373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44</TotalTime>
  <Words>188</Words>
  <Application>Microsoft Office PowerPoint</Application>
  <PresentationFormat>A4 Paper (210x297 mm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Elías Morande</dc:creator>
  <cp:lastModifiedBy>Pablo Elias Morande</cp:lastModifiedBy>
  <cp:revision>382</cp:revision>
  <dcterms:created xsi:type="dcterms:W3CDTF">2020-06-27T10:42:20Z</dcterms:created>
  <dcterms:modified xsi:type="dcterms:W3CDTF">2021-07-02T09:49:12Z</dcterms:modified>
</cp:coreProperties>
</file>